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5507" autoAdjust="0"/>
  </p:normalViewPr>
  <p:slideViewPr>
    <p:cSldViewPr>
      <p:cViewPr>
        <p:scale>
          <a:sx n="100" d="100"/>
          <a:sy n="100" d="100"/>
        </p:scale>
        <p:origin x="-1932" y="19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69" d="100"/>
          <a:sy n="69" d="100"/>
        </p:scale>
        <p:origin x="-3318" y="-108"/>
      </p:cViewPr>
      <p:guideLst>
        <p:guide orient="horz" pos="2880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AE0317-2D7F-4673-947D-90D17518E732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22D13-81D1-4FB3-882E-AFE98270DF5A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D22D13-81D1-4FB3-882E-AFE98270DF5A}" type="slidenum">
              <a:rPr lang="ru-RU" smtClean="0"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51C4F-BB55-4D35-9DA6-92F82B0F7D2C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A41C8-4584-453C-B40E-30D29219CCDC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 descr="IRF1 TIMER pan cancers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00042" y="214282"/>
            <a:ext cx="5929354" cy="2767032"/>
          </a:xfrm>
          <a:prstGeom prst="rect">
            <a:avLst/>
          </a:prstGeom>
        </p:spPr>
      </p:pic>
      <p:pic>
        <p:nvPicPr>
          <p:cNvPr id="5" name="Рисунок 4" descr="IRF1_TNM_pan cancers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71480" y="3000364"/>
            <a:ext cx="5786478" cy="2012687"/>
          </a:xfrm>
          <a:prstGeom prst="rect">
            <a:avLst/>
          </a:prstGeom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283429" y="5265698"/>
            <a:ext cx="2218344" cy="155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82184" y="5214942"/>
            <a:ext cx="2258848" cy="15956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305222" y="6867161"/>
            <a:ext cx="2196552" cy="15624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856264" y="6852170"/>
            <a:ext cx="2215942" cy="1544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4"/>
          <p:cNvSpPr txBox="1"/>
          <p:nvPr/>
        </p:nvSpPr>
        <p:spPr>
          <a:xfrm>
            <a:off x="2714620" y="5143504"/>
            <a:ext cx="196315" cy="1815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dirty="0" smtClean="0"/>
              <a:t>*</a:t>
            </a:r>
            <a:endParaRPr lang="ru-RU" dirty="0"/>
          </a:p>
        </p:txBody>
      </p:sp>
      <p:sp>
        <p:nvSpPr>
          <p:cNvPr id="16" name="TextBox 15"/>
          <p:cNvSpPr txBox="1"/>
          <p:nvPr/>
        </p:nvSpPr>
        <p:spPr>
          <a:xfrm>
            <a:off x="5286388" y="5643570"/>
            <a:ext cx="196315" cy="1815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dirty="0" smtClean="0"/>
              <a:t>*</a:t>
            </a:r>
            <a:endParaRPr lang="ru-RU" dirty="0"/>
          </a:p>
        </p:txBody>
      </p:sp>
      <p:sp>
        <p:nvSpPr>
          <p:cNvPr id="17" name="TextBox 16"/>
          <p:cNvSpPr txBox="1"/>
          <p:nvPr/>
        </p:nvSpPr>
        <p:spPr>
          <a:xfrm>
            <a:off x="2786058" y="6715140"/>
            <a:ext cx="196315" cy="1815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dirty="0" smtClean="0"/>
              <a:t>*</a:t>
            </a:r>
            <a:endParaRPr lang="ru-RU" dirty="0"/>
          </a:p>
        </p:txBody>
      </p:sp>
      <p:sp>
        <p:nvSpPr>
          <p:cNvPr id="18" name="TextBox 17"/>
          <p:cNvSpPr txBox="1"/>
          <p:nvPr/>
        </p:nvSpPr>
        <p:spPr>
          <a:xfrm>
            <a:off x="2064177" y="5024770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LUAD</a:t>
            </a:r>
            <a:endParaRPr lang="ru-RU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07383" y="5024770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LUSC</a:t>
            </a:r>
            <a:endParaRPr lang="ru-RU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00038" y="6538158"/>
            <a:ext cx="2351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rotein                         mRNA</a:t>
            </a:r>
            <a:endParaRPr lang="ru-R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14290" y="13070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A</a:t>
            </a:r>
            <a:endParaRPr lang="ru-R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4290" y="290690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B</a:t>
            </a:r>
            <a:endParaRPr lang="ru-R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4290" y="505004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C</a:t>
            </a:r>
            <a:endParaRPr lang="ru-R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1414" y="8429652"/>
            <a:ext cx="6786586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igure S1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. IRF1 gene expression in multiple cancers. A, IRF1 mRNA levels from TIMER (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DiffExp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module). *p&lt; 0.05, **p&lt; 0.01 and ***p&lt;0.001. B, IRF1 mRNA levels from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TNMplot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. Left box is normal, right box is tumor. *p&lt;0.01 (marked with red color). C, Bars showing IRF1 mRNA and protein in all primary tumors LUAD or LUSC compared to normal tissues (UALCAN database). *p&lt;0.05.</a:t>
            </a:r>
            <a:endParaRPr lang="ru-RU" sz="1000" dirty="0">
              <a:latin typeface="Arial" pitchFamily="34" charset="0"/>
              <a:cs typeface="Arial" pitchFamily="34" charset="0"/>
            </a:endParaRPr>
          </a:p>
          <a:p>
            <a:endParaRPr lang="ru-R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Прямоугольник 24"/>
          <p:cNvSpPr/>
          <p:nvPr/>
        </p:nvSpPr>
        <p:spPr>
          <a:xfrm>
            <a:off x="3857628" y="142844"/>
            <a:ext cx="428628" cy="27146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Прямоугольник 25"/>
          <p:cNvSpPr/>
          <p:nvPr/>
        </p:nvSpPr>
        <p:spPr>
          <a:xfrm>
            <a:off x="2571744" y="2928926"/>
            <a:ext cx="500066" cy="200026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97</Words>
  <Application>Microsoft Office PowerPoint</Application>
  <PresentationFormat>Экран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HP</dc:creator>
  <cp:lastModifiedBy>HP</cp:lastModifiedBy>
  <cp:revision>2</cp:revision>
  <dcterms:created xsi:type="dcterms:W3CDTF">2026-04-06T06:29:00Z</dcterms:created>
  <dcterms:modified xsi:type="dcterms:W3CDTF">2026-04-06T06:52:38Z</dcterms:modified>
</cp:coreProperties>
</file>